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06" r:id="rId2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E77"/>
    <a:srgbClr val="FF8AD8"/>
    <a:srgbClr val="F2F2F2"/>
    <a:srgbClr val="FAFAFA"/>
    <a:srgbClr val="5C66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F2DE63D5-997A-4646-A377-4702673A728D}" styleName="Style léger 2 - Accentuation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87" autoAdjust="0"/>
    <p:restoredTop sz="94277"/>
  </p:normalViewPr>
  <p:slideViewPr>
    <p:cSldViewPr snapToGrid="0">
      <p:cViewPr varScale="1">
        <p:scale>
          <a:sx n="75" d="100"/>
          <a:sy n="75" d="100"/>
        </p:scale>
        <p:origin x="3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E9E69-94B8-6846-8831-8FFB33FB9D64}" type="datetimeFigureOut">
              <a:rPr lang="fr-FR" smtClean="0"/>
              <a:t>24/10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2FD0DA-937E-B24B-9D15-1C64ED810B6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4773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871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903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82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8332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195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8425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687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58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1590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67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705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44808C-BCD8-4184-8275-C74A81F64D98}" type="datetimeFigureOut">
              <a:rPr lang="en-US" smtClean="0"/>
              <a:t>10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BE8A1C-422E-48F1-A80E-0ECBD71154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0365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3CA9B22A-2AD7-136C-8A70-BEAC6613920B}"/>
              </a:ext>
            </a:extLst>
          </p:cNvPr>
          <p:cNvGraphicFramePr>
            <a:graphicFrameLocks noGrp="1"/>
          </p:cNvGraphicFramePr>
          <p:nvPr/>
        </p:nvGraphicFramePr>
        <p:xfrm>
          <a:off x="98916" y="1431462"/>
          <a:ext cx="5551436" cy="122545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68009">
                  <a:extLst>
                    <a:ext uri="{9D8B030D-6E8A-4147-A177-3AD203B41FA5}">
                      <a16:colId xmlns:a16="http://schemas.microsoft.com/office/drawing/2014/main" val="2918265949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1283214527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1197020346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904022696"/>
                    </a:ext>
                  </a:extLst>
                </a:gridCol>
                <a:gridCol w="239953">
                  <a:extLst>
                    <a:ext uri="{9D8B030D-6E8A-4147-A177-3AD203B41FA5}">
                      <a16:colId xmlns:a16="http://schemas.microsoft.com/office/drawing/2014/main" val="3871948454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3660592918"/>
                    </a:ext>
                  </a:extLst>
                </a:gridCol>
                <a:gridCol w="251814">
                  <a:extLst>
                    <a:ext uri="{9D8B030D-6E8A-4147-A177-3AD203B41FA5}">
                      <a16:colId xmlns:a16="http://schemas.microsoft.com/office/drawing/2014/main" val="1178302097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1856210464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2715872486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1830716725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801758677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541600701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2056436105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3439441115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4285362120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4075179584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3241986736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875016419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2702538438"/>
                    </a:ext>
                  </a:extLst>
                </a:gridCol>
                <a:gridCol w="186631">
                  <a:extLst>
                    <a:ext uri="{9D8B030D-6E8A-4147-A177-3AD203B41FA5}">
                      <a16:colId xmlns:a16="http://schemas.microsoft.com/office/drawing/2014/main" val="2366036779"/>
                    </a:ext>
                  </a:extLst>
                </a:gridCol>
                <a:gridCol w="251814">
                  <a:extLst>
                    <a:ext uri="{9D8B030D-6E8A-4147-A177-3AD203B41FA5}">
                      <a16:colId xmlns:a16="http://schemas.microsoft.com/office/drawing/2014/main" val="2340370637"/>
                    </a:ext>
                  </a:extLst>
                </a:gridCol>
                <a:gridCol w="267119">
                  <a:extLst>
                    <a:ext uri="{9D8B030D-6E8A-4147-A177-3AD203B41FA5}">
                      <a16:colId xmlns:a16="http://schemas.microsoft.com/office/drawing/2014/main" val="159509088"/>
                    </a:ext>
                  </a:extLst>
                </a:gridCol>
              </a:tblGrid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HA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FR" sz="6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2834934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mino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id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ositio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2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3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4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9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63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8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23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72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91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72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79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50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54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4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95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27</a:t>
                      </a:r>
                    </a:p>
                  </a:txBody>
                  <a:tcPr marL="5146" marR="5146" marT="5146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6798919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Ohio/1/2003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87285812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South 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frica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4/2003 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56737927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Ohio/113461-1/2005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4623960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Richmond/2007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1558476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equine/Beuvron-en-Auge/2/2009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6872881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Paris/1/201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9666974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63CB693-1D7D-4552-D060-969AE4B3BEDB}"/>
              </a:ext>
            </a:extLst>
          </p:cNvPr>
          <p:cNvGraphicFramePr>
            <a:graphicFrameLocks noGrp="1"/>
          </p:cNvGraphicFramePr>
          <p:nvPr/>
        </p:nvGraphicFramePr>
        <p:xfrm>
          <a:off x="212305" y="3649937"/>
          <a:ext cx="6484582" cy="122545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0467">
                  <a:extLst>
                    <a:ext uri="{9D8B030D-6E8A-4147-A177-3AD203B41FA5}">
                      <a16:colId xmlns:a16="http://schemas.microsoft.com/office/drawing/2014/main" val="4289615965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225137924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1835236795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4148837306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753783142"/>
                    </a:ext>
                  </a:extLst>
                </a:gridCol>
                <a:gridCol w="213160">
                  <a:extLst>
                    <a:ext uri="{9D8B030D-6E8A-4147-A177-3AD203B41FA5}">
                      <a16:colId xmlns:a16="http://schemas.microsoft.com/office/drawing/2014/main" val="3397995073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2296300629"/>
                    </a:ext>
                  </a:extLst>
                </a:gridCol>
                <a:gridCol w="223697">
                  <a:extLst>
                    <a:ext uri="{9D8B030D-6E8A-4147-A177-3AD203B41FA5}">
                      <a16:colId xmlns:a16="http://schemas.microsoft.com/office/drawing/2014/main" val="1530146047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421974956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408638362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2966096772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734044750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1749383396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761554353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1591052540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3166839088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1005538224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3670502516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3270942129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2904439718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1778978110"/>
                    </a:ext>
                  </a:extLst>
                </a:gridCol>
                <a:gridCol w="223697">
                  <a:extLst>
                    <a:ext uri="{9D8B030D-6E8A-4147-A177-3AD203B41FA5}">
                      <a16:colId xmlns:a16="http://schemas.microsoft.com/office/drawing/2014/main" val="2807834402"/>
                    </a:ext>
                  </a:extLst>
                </a:gridCol>
                <a:gridCol w="237292">
                  <a:extLst>
                    <a:ext uri="{9D8B030D-6E8A-4147-A177-3AD203B41FA5}">
                      <a16:colId xmlns:a16="http://schemas.microsoft.com/office/drawing/2014/main" val="3061479713"/>
                    </a:ext>
                  </a:extLst>
                </a:gridCol>
                <a:gridCol w="237292">
                  <a:extLst>
                    <a:ext uri="{9D8B030D-6E8A-4147-A177-3AD203B41FA5}">
                      <a16:colId xmlns:a16="http://schemas.microsoft.com/office/drawing/2014/main" val="1828167954"/>
                    </a:ext>
                  </a:extLst>
                </a:gridCol>
                <a:gridCol w="237292">
                  <a:extLst>
                    <a:ext uri="{9D8B030D-6E8A-4147-A177-3AD203B41FA5}">
                      <a16:colId xmlns:a16="http://schemas.microsoft.com/office/drawing/2014/main" val="3960999081"/>
                    </a:ext>
                  </a:extLst>
                </a:gridCol>
                <a:gridCol w="236760">
                  <a:extLst>
                    <a:ext uri="{9D8B030D-6E8A-4147-A177-3AD203B41FA5}">
                      <a16:colId xmlns:a16="http://schemas.microsoft.com/office/drawing/2014/main" val="3606621525"/>
                    </a:ext>
                  </a:extLst>
                </a:gridCol>
                <a:gridCol w="236760">
                  <a:extLst>
                    <a:ext uri="{9D8B030D-6E8A-4147-A177-3AD203B41FA5}">
                      <a16:colId xmlns:a16="http://schemas.microsoft.com/office/drawing/2014/main" val="3088207107"/>
                    </a:ext>
                  </a:extLst>
                </a:gridCol>
                <a:gridCol w="165792">
                  <a:extLst>
                    <a:ext uri="{9D8B030D-6E8A-4147-A177-3AD203B41FA5}">
                      <a16:colId xmlns:a16="http://schemas.microsoft.com/office/drawing/2014/main" val="432618339"/>
                    </a:ext>
                  </a:extLst>
                </a:gridCol>
                <a:gridCol w="228117">
                  <a:extLst>
                    <a:ext uri="{9D8B030D-6E8A-4147-A177-3AD203B41FA5}">
                      <a16:colId xmlns:a16="http://schemas.microsoft.com/office/drawing/2014/main" val="644090672"/>
                    </a:ext>
                  </a:extLst>
                </a:gridCol>
              </a:tblGrid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8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1940568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mino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id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ositio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2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7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6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0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4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6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47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86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91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3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5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52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5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60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71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37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10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16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34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0098078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Ohio/1/2003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Y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600" b="1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2584570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South 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frica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4/2003 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0928681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Ohio/113461-1/2005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8939819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Richmond/2007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791672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equine/Beuvron-en-Auge/2/2009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7667842"/>
                  </a:ext>
                </a:extLst>
              </a:tr>
              <a:tr h="153182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/</a:t>
                      </a:r>
                      <a:r>
                        <a:rPr lang="fr-FR" sz="600" b="0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quine</a:t>
                      </a:r>
                      <a:r>
                        <a:rPr lang="fr-FR" sz="6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Paris/1/2018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</a:t>
                      </a:r>
                    </a:p>
                  </a:txBody>
                  <a:tcPr marL="5146" marR="5146" marT="5146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kumimoji="0" lang="fr-FR" sz="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FR" sz="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685800" rtl="0" eaLnBrk="1" fontAlgn="b" latinLnBrk="0" hangingPunct="1"/>
                      <a:r>
                        <a:rPr lang="fr-FR" sz="600" b="1" i="0" u="none" strike="noStrike" kern="120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</a:t>
                      </a:r>
                      <a:endParaRPr lang="fr-FR" sz="600" b="1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146" marR="5146" marT="5146" marB="0" anchor="ctr"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33247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2978632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5176</TotalTime>
  <Words>436</Words>
  <Application>Microsoft Macintosh PowerPoint</Application>
  <PresentationFormat>A4 Paper (210x297 mm)</PresentationFormat>
  <Paragraphs>3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e POLLET</dc:creator>
  <cp:lastModifiedBy>Lena Kleij</cp:lastModifiedBy>
  <cp:revision>237</cp:revision>
  <cp:lastPrinted>2023-10-09T13:57:45Z</cp:lastPrinted>
  <dcterms:created xsi:type="dcterms:W3CDTF">2023-02-16T15:54:12Z</dcterms:created>
  <dcterms:modified xsi:type="dcterms:W3CDTF">2023-10-24T12:36:32Z</dcterms:modified>
</cp:coreProperties>
</file>